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danzQC-JF" initials="JF" lastIdx="3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660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CE91D1-E404-4EAB-9FB6-C6531D0D406C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981200" y="739775"/>
            <a:ext cx="2773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8936C8-C058-4491-BDDA-56099C80B65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4672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8936C8-C058-4491-BDDA-56099C80B65E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98142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6785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1100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365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9438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6886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8342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2429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66430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8205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75829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17537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001CA9-679D-4A09-8571-7C27108AC0F5}" type="datetimeFigureOut">
              <a:rPr kumimoji="1" lang="ja-JP" altLang="en-US" smtClean="0"/>
              <a:pPr/>
              <a:t>2015/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CD6542-F6DC-4A2E-9FEB-08BF15D83EC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84160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0" y="-887"/>
            <a:ext cx="23038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US" altLang="ja-JP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グループ化 2"/>
          <p:cNvGrpSpPr/>
          <p:nvPr/>
        </p:nvGrpSpPr>
        <p:grpSpPr>
          <a:xfrm>
            <a:off x="531979" y="3575583"/>
            <a:ext cx="5794042" cy="4956857"/>
            <a:chOff x="531979" y="611559"/>
            <a:chExt cx="5794042" cy="4956857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 rotWithShape="1"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4400" t="28350" r="10089"/>
            <a:stretch/>
          </p:blipFill>
          <p:spPr bwMode="auto">
            <a:xfrm>
              <a:off x="531979" y="611559"/>
              <a:ext cx="5794042" cy="49568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テキスト ボックス 4"/>
            <p:cNvSpPr txBox="1"/>
            <p:nvPr/>
          </p:nvSpPr>
          <p:spPr>
            <a:xfrm>
              <a:off x="2533005" y="1024624"/>
              <a:ext cx="6480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2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r>
                <a:rPr lang="en-US" altLang="ja-JP" sz="2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endParaRPr lang="ja-JP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" name="テキスト ボックス 5"/>
          <p:cNvSpPr txBox="1"/>
          <p:nvPr/>
        </p:nvSpPr>
        <p:spPr>
          <a:xfrm>
            <a:off x="58316" y="683568"/>
            <a:ext cx="6611044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2 - Biofilm formation by homotypic </a:t>
            </a:r>
            <a:r>
              <a:rPr lang="en-US" altLang="ja-JP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gingivalis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3277 or ECF sigma </a:t>
            </a:r>
            <a:endParaRPr lang="en-US" altLang="ja-JP" sz="14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ctor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s using non-coated microplate.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rains were grown on enriched BHI broth anaerobically at 37 °C</a:t>
            </a:r>
            <a:r>
              <a:rPr lang="en-US" altLang="ja-JP" sz="1400" dirty="0"/>
              <a:t> 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coated 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-well flat-bottom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roplates. After 48 h of cultivation, b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ofilm formation was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rmined by crystal violet staining and 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justed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growth (A</a:t>
            </a:r>
            <a:r>
              <a:rPr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0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nits per OD</a:t>
            </a:r>
            <a:r>
              <a:rPr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60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nit). The data shown are mean ± SD of triplicate 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s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***, 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1, by a one-way ANOVA Test/Dunnett's Multiple Comparison Test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09186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5</TotalTime>
  <Words>95</Words>
  <Application>Microsoft Office PowerPoint</Application>
  <PresentationFormat>画面に合わせる (4:3)</PresentationFormat>
  <Paragraphs>6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菊池有一郎</dc:creator>
  <cp:lastModifiedBy>菊池有一郎</cp:lastModifiedBy>
  <cp:revision>49</cp:revision>
  <cp:lastPrinted>2014-11-25T09:31:52Z</cp:lastPrinted>
  <dcterms:created xsi:type="dcterms:W3CDTF">2014-12-22T02:55:55Z</dcterms:created>
  <dcterms:modified xsi:type="dcterms:W3CDTF">2015-01-05T01:48:35Z</dcterms:modified>
</cp:coreProperties>
</file>